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2BE81B-FD8F-8B4E-AA58-F87D767A175A}" type="datetimeFigureOut">
              <a:rPr lang="en-US" smtClean="0"/>
              <a:t>4/1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9DE703-415B-0548-895A-4295BAD28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7037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BDC91C-1552-6E47-8464-2D5A4C5D201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8753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6681BA-DB9A-674D-FA58-05CA44390F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7FD58A-422B-94B0-41C3-65C4B0FD3B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9D579E-5AEB-7B28-DDDD-363A17B8A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96908D-1F34-68F8-8B61-27B28A356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0352C9-648D-613D-2F59-881A6E137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988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7D332E-D182-E7C1-EAB5-5E9D043670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6BDBDC-C0B2-664B-19C0-C256A74347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6D701B-BFB5-6BCC-8928-8F0E72AB4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5292DA-B0D9-7A6C-4CD1-5CC481E0B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73BFCB-25D7-F6F3-F8AC-3D5C7F189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174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6112C74-E021-2F9C-E35F-784A187EE8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12A263-7E85-7943-AAA9-774D8F9196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783171-B4AD-6744-F5B1-47D189213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6ED5CA-1215-693B-6729-CE80B6D76B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EEDD1B-4AB7-4247-D498-201F4CEC7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125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9E8116-7208-E8CD-3ADA-C895FAB746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FCB447-CC5E-D0F2-705B-69A13244DF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198C83-42C3-C2BB-361A-B08276751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F47AF8-11D9-5BED-CD16-53B116AA2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E2B6DB-96D4-377A-5120-95EDF8E44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752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85D150-39C4-EE40-461A-DDF783BD6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967323-96CA-126D-86B3-F1E86F0129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854AB6-71DF-905F-817A-47310ACA2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C51782-2AD3-C36A-0C47-57F83B317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6BDA1-06F7-21C3-0E59-6EC0DECC5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221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6E1603-2FE1-0D01-68E5-E34B2D6D14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4ECEAC-A42C-C6C0-1677-D4756C1698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AE4039-39FA-8448-003E-2C5E052BF1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56266E-0A76-4928-1651-9F78DA2B0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60210F-FC91-E360-3479-CD5667AF8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801A0D-3C6D-AE6D-1441-4D770F7B9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499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50D818-7C4D-41F5-5858-2AD8B7DCBC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BE09B0-B659-CB8A-9151-62EEDE32DC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14840B-C50B-4539-DADE-414254BB5D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800C80A-4F8F-62F7-BDF7-D46DFB47D3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BADA8F-76E8-EEBC-8502-8C8DA4E532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EB82653-579A-114F-FDC2-41B86386F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4CECDE-2C35-0DD3-6545-1C657FC0E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1A7B08-DAFD-83C6-ED96-4296F0CE9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055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06DCF-6139-4092-D128-78908F8D10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EED077C-D628-0F44-B1CA-656DA6AAB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76A36D-269B-EFAB-C3A3-DD6348516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0BD23E-01A3-EDEA-4357-BAD264D32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326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387112-BC68-C2F3-AC0E-60DFC90BD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E063C38-3F9E-7C81-ED99-56E8E6EC1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2D8BBC-C092-E698-3F77-E810DC3B1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461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5BC22-500E-93CC-E72C-22385685C3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BEA690-210F-5842-EE58-4EBE903858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F2A9A0-62E0-3B29-13EB-8347ECD14E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21EFF7-6F6B-886C-426A-AB56746305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6BE4C2-47EC-6573-FDFA-AFC37C756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72F83C-7D49-9D51-2C82-1BA7D5DAF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578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985A6A-0F12-AFD9-36BD-5778CBBFC6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25A5863-10A2-28E8-090C-81B006CEB7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60D258-EFAA-5C23-960E-0F4456C7F4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4E9B51-9310-99F5-0EA4-204EACF9E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317BAC-524B-9E1E-ACD3-B10902F9F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B2689E-6473-A375-266A-DB660215F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892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06470BF-5752-D031-C7BD-D918ECC3F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B9AF4D-6D15-09B6-373F-4A55E98079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E3F9E5-7879-E23C-DA78-090334191E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02D8B-B7C6-CC49-B762-56B3115BB83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FAB1AA-A2C5-54E4-6E6E-5A39C3585F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07FCDE-A6C7-157F-318A-A29DF56857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C9A81-FB2A-2E4A-AE99-E291CDB782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542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9AFD081-3EF3-4AB2-BF4A-60300E40B876}"/>
              </a:ext>
            </a:extLst>
          </p:cNvPr>
          <p:cNvGraphicFramePr>
            <a:graphicFrameLocks noGrp="1"/>
          </p:cNvGraphicFramePr>
          <p:nvPr/>
        </p:nvGraphicFramePr>
        <p:xfrm>
          <a:off x="2623127" y="-226423"/>
          <a:ext cx="7906328" cy="656256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07075">
                  <a:extLst>
                    <a:ext uri="{9D8B030D-6E8A-4147-A177-3AD203B41FA5}">
                      <a16:colId xmlns:a16="http://schemas.microsoft.com/office/drawing/2014/main" val="1317664448"/>
                    </a:ext>
                  </a:extLst>
                </a:gridCol>
                <a:gridCol w="2499253">
                  <a:extLst>
                    <a:ext uri="{9D8B030D-6E8A-4147-A177-3AD203B41FA5}">
                      <a16:colId xmlns:a16="http://schemas.microsoft.com/office/drawing/2014/main" val="1599689662"/>
                    </a:ext>
                  </a:extLst>
                </a:gridCol>
              </a:tblGrid>
              <a:tr h="643992">
                <a:tc gridSpan="2">
                  <a:txBody>
                    <a:bodyPr/>
                    <a:lstStyle/>
                    <a:p>
                      <a:pPr algn="l"/>
                      <a:r>
                        <a:rPr lang="en-US" sz="1100" b="1" dirty="0"/>
                        <a:t>Supplementary Table 3: </a:t>
                      </a:r>
                      <a:r>
                        <a:rPr lang="en-US" sz="1100" b="0" dirty="0"/>
                        <a:t>Summary of Electroconvulsive Therapy</a:t>
                      </a: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1000" b="1" dirty="0"/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8143961"/>
                  </a:ext>
                </a:extLst>
              </a:tr>
              <a:tr h="285511"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b="1" i="1" dirty="0"/>
                        <a:t>Demographic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b="1" i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61165240"/>
                  </a:ext>
                </a:extLst>
              </a:tr>
              <a:tr h="346106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Total number of patients who received ECT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9/31 (29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71725949"/>
                  </a:ext>
                </a:extLst>
              </a:tr>
              <a:tr h="470255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Ag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Mean = 15.6, Median = 15</a:t>
                      </a:r>
                    </a:p>
                    <a:p>
                      <a:pPr algn="ctr" fontAlgn="t"/>
                      <a:r>
                        <a:rPr lang="en-US" sz="1100" dirty="0">
                          <a:effectLst/>
                        </a:rPr>
                        <a:t>(Min = 14, Max = 17, SD=1.0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2951378"/>
                  </a:ext>
                </a:extLst>
              </a:tr>
              <a:tr h="390174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Biologically Femal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5/9 (56%)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89013895"/>
                  </a:ext>
                </a:extLst>
              </a:tr>
              <a:tr h="390174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Biologically Mal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4/9 (44%)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28013927"/>
                  </a:ext>
                </a:extLst>
              </a:tr>
              <a:tr h="285511"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b="1" i="1" dirty="0"/>
                        <a:t>Ethnic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b="1" i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61353497"/>
                  </a:ext>
                </a:extLst>
              </a:tr>
              <a:tr h="319605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Whit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5/9 (56%)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8635309"/>
                  </a:ext>
                </a:extLst>
              </a:tr>
              <a:tr h="298957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Black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1/9 (11%)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994381"/>
                  </a:ext>
                </a:extLst>
              </a:tr>
              <a:tr h="298160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Hispanic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2/9 (22%)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39162045"/>
                  </a:ext>
                </a:extLst>
              </a:tr>
              <a:tr h="285511"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b="1" i="1" dirty="0"/>
                        <a:t>Total and Frequency of ECT Treatment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b="1" i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5066470"/>
                  </a:ext>
                </a:extLst>
              </a:tr>
              <a:tr h="474453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Total number of ECT treatment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Mean = 20, Median 18</a:t>
                      </a:r>
                    </a:p>
                    <a:p>
                      <a:pPr algn="ctr" fontAlgn="t"/>
                      <a:r>
                        <a:rPr lang="en-US" sz="1100" dirty="0">
                          <a:effectLst/>
                        </a:rPr>
                        <a:t>(Min = 11, Max = 34, SD = 7.9)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45107742"/>
                  </a:ext>
                </a:extLst>
              </a:tr>
              <a:tr h="474453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Number of days between ECT treatment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Mean = 5.9, Median = 4</a:t>
                      </a:r>
                    </a:p>
                    <a:p>
                      <a:pPr algn="ctr" fontAlgn="t"/>
                      <a:r>
                        <a:rPr lang="en-US" sz="1100" dirty="0">
                          <a:effectLst/>
                        </a:rPr>
                        <a:t>(Min = 1, Max = 51, SD = 7.2)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90892495"/>
                  </a:ext>
                </a:extLst>
              </a:tr>
              <a:tr h="285511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/>
                        <a:t>ECT Parameter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900" dirty="0">
                        <a:effectLst/>
                      </a:endParaRP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33240439"/>
                  </a:ext>
                </a:extLst>
              </a:tr>
              <a:tr h="470255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Total number of patients with brief pulse and bitemporal electrode placement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9/9 (100%)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31017210"/>
                  </a:ext>
                </a:extLst>
              </a:tr>
              <a:tr h="843939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Average charg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Mean = 526.7 </a:t>
                      </a:r>
                      <a:r>
                        <a:rPr lang="en-US" sz="1100" dirty="0" err="1">
                          <a:effectLst/>
                        </a:rPr>
                        <a:t>mC</a:t>
                      </a:r>
                      <a:r>
                        <a:rPr lang="en-US" sz="1100" dirty="0">
                          <a:effectLst/>
                        </a:rPr>
                        <a:t>, Median = 503.1 </a:t>
                      </a:r>
                      <a:r>
                        <a:rPr lang="en-US" sz="1100" dirty="0" err="1">
                          <a:effectLst/>
                        </a:rPr>
                        <a:t>mC</a:t>
                      </a:r>
                      <a:endParaRPr lang="en-US" sz="1100" dirty="0">
                        <a:effectLst/>
                      </a:endParaRPr>
                    </a:p>
                    <a:p>
                      <a:pPr algn="ctr" fontAlgn="t"/>
                      <a:r>
                        <a:rPr lang="en-US" sz="1100" dirty="0">
                          <a:effectLst/>
                        </a:rPr>
                        <a:t>(Min = 500.9 </a:t>
                      </a:r>
                      <a:r>
                        <a:rPr lang="en-US" sz="1100" dirty="0" err="1">
                          <a:effectLst/>
                        </a:rPr>
                        <a:t>mC</a:t>
                      </a:r>
                      <a:r>
                        <a:rPr lang="en-US" sz="1100" dirty="0">
                          <a:effectLst/>
                        </a:rPr>
                        <a:t>, Max = 576 </a:t>
                      </a:r>
                      <a:r>
                        <a:rPr lang="en-US" sz="1100" dirty="0" err="1">
                          <a:effectLst/>
                        </a:rPr>
                        <a:t>mC</a:t>
                      </a:r>
                      <a:r>
                        <a:rPr lang="en-US" sz="1100" dirty="0">
                          <a:effectLst/>
                        </a:rPr>
                        <a:t>, SD = 37.0)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921088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46280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9</Words>
  <Application>Microsoft Macintosh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ith, Joshua Ryan</dc:creator>
  <cp:lastModifiedBy>Smith, Joshua Ryan</cp:lastModifiedBy>
  <cp:revision>1</cp:revision>
  <dcterms:created xsi:type="dcterms:W3CDTF">2023-04-12T21:16:33Z</dcterms:created>
  <dcterms:modified xsi:type="dcterms:W3CDTF">2023-04-12T21:16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92c8cef-6f2b-4af1-b4ac-d815ff795cd6_Enabled">
    <vt:lpwstr>true</vt:lpwstr>
  </property>
  <property fmtid="{D5CDD505-2E9C-101B-9397-08002B2CF9AE}" pid="3" name="MSIP_Label_792c8cef-6f2b-4af1-b4ac-d815ff795cd6_SetDate">
    <vt:lpwstr>2023-04-12T21:16:51Z</vt:lpwstr>
  </property>
  <property fmtid="{D5CDD505-2E9C-101B-9397-08002B2CF9AE}" pid="4" name="MSIP_Label_792c8cef-6f2b-4af1-b4ac-d815ff795cd6_Method">
    <vt:lpwstr>Standard</vt:lpwstr>
  </property>
  <property fmtid="{D5CDD505-2E9C-101B-9397-08002B2CF9AE}" pid="5" name="MSIP_Label_792c8cef-6f2b-4af1-b4ac-d815ff795cd6_Name">
    <vt:lpwstr>VUMC General</vt:lpwstr>
  </property>
  <property fmtid="{D5CDD505-2E9C-101B-9397-08002B2CF9AE}" pid="6" name="MSIP_Label_792c8cef-6f2b-4af1-b4ac-d815ff795cd6_SiteId">
    <vt:lpwstr>ef575030-1424-4ed8-b83c-12c533d879ab</vt:lpwstr>
  </property>
  <property fmtid="{D5CDD505-2E9C-101B-9397-08002B2CF9AE}" pid="7" name="MSIP_Label_792c8cef-6f2b-4af1-b4ac-d815ff795cd6_ActionId">
    <vt:lpwstr>d5bd58d6-6a2d-4eed-bf0d-4f41db347d1f</vt:lpwstr>
  </property>
  <property fmtid="{D5CDD505-2E9C-101B-9397-08002B2CF9AE}" pid="8" name="MSIP_Label_792c8cef-6f2b-4af1-b4ac-d815ff795cd6_ContentBits">
    <vt:lpwstr>0</vt:lpwstr>
  </property>
</Properties>
</file>